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999538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93" y="-20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iqian Liu (DEECA)" userId="fdec7e5f-b261-41a4-8781-d540c2fc409b" providerId="ADAL" clId="{07BC2483-ED6E-48F9-A992-9AB3B9F8ABE9}"/>
    <pc:docChg chg="modSld">
      <pc:chgData name="Zhiqian Liu (DEECA)" userId="fdec7e5f-b261-41a4-8781-d540c2fc409b" providerId="ADAL" clId="{07BC2483-ED6E-48F9-A992-9AB3B9F8ABE9}" dt="2025-04-07T07:07:23.621" v="313" actId="2711"/>
      <pc:docMkLst>
        <pc:docMk/>
      </pc:docMkLst>
      <pc:sldChg chg="modSp mod">
        <pc:chgData name="Zhiqian Liu (DEECA)" userId="fdec7e5f-b261-41a4-8781-d540c2fc409b" providerId="ADAL" clId="{07BC2483-ED6E-48F9-A992-9AB3B9F8ABE9}" dt="2025-04-07T07:07:23.621" v="313" actId="2711"/>
        <pc:sldMkLst>
          <pc:docMk/>
          <pc:sldMk cId="602136024" sldId="256"/>
        </pc:sldMkLst>
        <pc:spChg chg="mod">
          <ac:chgData name="Zhiqian Liu (DEECA)" userId="fdec7e5f-b261-41a4-8781-d540c2fc409b" providerId="ADAL" clId="{07BC2483-ED6E-48F9-A992-9AB3B9F8ABE9}" dt="2025-04-07T07:07:23.621" v="313" actId="2711"/>
          <ac:spMkLst>
            <pc:docMk/>
            <pc:sldMk cId="602136024" sldId="256"/>
            <ac:spMk id="12" creationId="{5232A60C-E4C5-5692-C93C-52654D5323D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995312"/>
            <a:ext cx="7649607" cy="424462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6403623"/>
            <a:ext cx="6749654" cy="294357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66434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0925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649111"/>
            <a:ext cx="1940525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49111"/>
            <a:ext cx="5709082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66957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8999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039537"/>
            <a:ext cx="7762102" cy="5071532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8159048"/>
            <a:ext cx="7762102" cy="266699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>
                    <a:tint val="82000"/>
                  </a:schemeClr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82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82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01330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245556"/>
            <a:ext cx="3824804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245556"/>
            <a:ext cx="3824804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38093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49114"/>
            <a:ext cx="7762102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988734"/>
            <a:ext cx="3807226" cy="146473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4453467"/>
            <a:ext cx="3807226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988734"/>
            <a:ext cx="3825976" cy="146473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453467"/>
            <a:ext cx="3825976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8993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9501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6909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12800"/>
            <a:ext cx="2902585" cy="28448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755425"/>
            <a:ext cx="4556016" cy="8664222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657600"/>
            <a:ext cx="2902585" cy="6776156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08048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12800"/>
            <a:ext cx="2902585" cy="28448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755425"/>
            <a:ext cx="4556016" cy="8664222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657600"/>
            <a:ext cx="2902585" cy="6776156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4624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649114"/>
            <a:ext cx="7762102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245556"/>
            <a:ext cx="7762102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1300181"/>
            <a:ext cx="202489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03970B-F489-408E-B926-CD1A43CFC69F}" type="datetimeFigureOut">
              <a:rPr lang="en-AU" smtClean="0"/>
              <a:t>7/04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1300181"/>
            <a:ext cx="303734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1300181"/>
            <a:ext cx="202489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CA33D6-3780-449C-A501-3A72F4447E70}" type="slidenum">
              <a:rPr lang="en-AU" smtClean="0"/>
              <a:t>‹#›</a:t>
            </a:fld>
            <a:endParaRPr lang="en-AU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538EC50-04EF-D580-8651-14766A3617F5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ftr"/>
              </p:ext>
            </p:extLst>
          </p:nvPr>
        </p:nvSpPr>
        <p:spPr>
          <a:xfrm>
            <a:off x="4202875" y="11945620"/>
            <a:ext cx="628650" cy="18288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AU" sz="12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nofficial</a:t>
            </a:r>
          </a:p>
        </p:txBody>
      </p:sp>
    </p:spTree>
    <p:extLst>
      <p:ext uri="{BB962C8B-B14F-4D97-AF65-F5344CB8AC3E}">
        <p14:creationId xmlns:p14="http://schemas.microsoft.com/office/powerpoint/2010/main" val="3445023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3498FFAB-8314-1176-F5E1-C01B8BB199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4035" y="939377"/>
            <a:ext cx="5767690" cy="720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232A60C-E4C5-5692-C93C-52654D5323DC}"/>
              </a:ext>
            </a:extLst>
          </p:cNvPr>
          <p:cNvSpPr txBox="1"/>
          <p:nvPr/>
        </p:nvSpPr>
        <p:spPr>
          <a:xfrm flipH="1">
            <a:off x="1710265" y="7954711"/>
            <a:ext cx="5257801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Comparison of the top 5 lipids between the two lactation stages. A: 2022 cohort (n = 143); B: 2023 cohort (n = 218). Error bars are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602136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3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hiqian Liu (DEECA)</dc:creator>
  <cp:lastModifiedBy>Zhiqian Liu (DEECA)</cp:lastModifiedBy>
  <cp:revision>1</cp:revision>
  <dcterms:created xsi:type="dcterms:W3CDTF">2025-04-07T06:40:26Z</dcterms:created>
  <dcterms:modified xsi:type="dcterms:W3CDTF">2025-04-07T07:07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92b7feb-b287-442c-a072-f385b02ec972_Enabled">
    <vt:lpwstr>true</vt:lpwstr>
  </property>
  <property fmtid="{D5CDD505-2E9C-101B-9397-08002B2CF9AE}" pid="3" name="MSIP_Label_b92b7feb-b287-442c-a072-f385b02ec972_SetDate">
    <vt:lpwstr>2025-04-07T06:43:10Z</vt:lpwstr>
  </property>
  <property fmtid="{D5CDD505-2E9C-101B-9397-08002B2CF9AE}" pid="4" name="MSIP_Label_b92b7feb-b287-442c-a072-f385b02ec972_Method">
    <vt:lpwstr>Privileged</vt:lpwstr>
  </property>
  <property fmtid="{D5CDD505-2E9C-101B-9397-08002B2CF9AE}" pid="5" name="MSIP_Label_b92b7feb-b287-442c-a072-f385b02ec972_Name">
    <vt:lpwstr>Unofficial</vt:lpwstr>
  </property>
  <property fmtid="{D5CDD505-2E9C-101B-9397-08002B2CF9AE}" pid="6" name="MSIP_Label_b92b7feb-b287-442c-a072-f385b02ec972_SiteId">
    <vt:lpwstr>e8bdd6f7-fc18-4e48-a554-7f547927223b</vt:lpwstr>
  </property>
  <property fmtid="{D5CDD505-2E9C-101B-9397-08002B2CF9AE}" pid="7" name="MSIP_Label_b92b7feb-b287-442c-a072-f385b02ec972_ActionId">
    <vt:lpwstr>0b234ed4-d930-43d4-9bf5-b823ac1481bc</vt:lpwstr>
  </property>
  <property fmtid="{D5CDD505-2E9C-101B-9397-08002B2CF9AE}" pid="8" name="MSIP_Label_b92b7feb-b287-442c-a072-f385b02ec972_ContentBits">
    <vt:lpwstr>2</vt:lpwstr>
  </property>
  <property fmtid="{D5CDD505-2E9C-101B-9397-08002B2CF9AE}" pid="9" name="MSIP_Label_b92b7feb-b287-442c-a072-f385b02ec972_Tag">
    <vt:lpwstr>10, 0, 1, 1</vt:lpwstr>
  </property>
  <property fmtid="{D5CDD505-2E9C-101B-9397-08002B2CF9AE}" pid="10" name="ClassificationContentMarkingFooterLocations">
    <vt:lpwstr>Office Theme:8</vt:lpwstr>
  </property>
  <property fmtid="{D5CDD505-2E9C-101B-9397-08002B2CF9AE}" pid="11" name="ClassificationContentMarkingFooterText">
    <vt:lpwstr>Unofficial</vt:lpwstr>
  </property>
</Properties>
</file>